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4F583DB-FD95-40E1-914A-076634F8BDDF}" v="10" dt="2024-05-29T17:43:11.8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05"/>
  </p:normalViewPr>
  <p:slideViewPr>
    <p:cSldViewPr snapToGrid="0">
      <p:cViewPr>
        <p:scale>
          <a:sx n="90" d="100"/>
          <a:sy n="90" d="100"/>
        </p:scale>
        <p:origin x="1810" y="-18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48A48E-D208-3A4C-A393-077F59EF4CE5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0F70B1-046A-B945-8B51-C60BD307CA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8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0F70B1-046A-B945-8B51-C60BD307CA8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7395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387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112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881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02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831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955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935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308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55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75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045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19178C-6470-DA44-9F87-0F6DE6D0EDBF}" type="datetimeFigureOut">
              <a:rPr lang="en-US" smtClean="0"/>
              <a:t>6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3E0F3C-45EC-0D4E-A983-6C4C3C238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35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DE5B774-8CDD-E84B-01F8-828F34BB38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203" y="3881970"/>
            <a:ext cx="4882828" cy="325521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FF7916A-DBBB-8337-298B-F41437D8DAFA}"/>
              </a:ext>
            </a:extLst>
          </p:cNvPr>
          <p:cNvSpPr txBox="1"/>
          <p:nvPr/>
        </p:nvSpPr>
        <p:spPr>
          <a:xfrm>
            <a:off x="1003629" y="7168709"/>
            <a:ext cx="5082769" cy="15696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l Figure S1:</a:t>
            </a:r>
            <a:r>
              <a:rPr lang="en-US" sz="1200" dirty="0">
                <a:latin typeface="Arial"/>
                <a:cs typeface="Arial"/>
              </a:rPr>
              <a:t> Random forest classifier performance. A) Receiver operating characteristic (ROC) curve of the classifier trained on alfalfa sprouts data and tested with broccoli sprouts data. Area-under-the-ROC-curve score of 0.95 indicate strong prediction performance.   B) Precision recall curve of a machine learning classifier trained on candidates from alfalfa sprouts and tested on candidates from broccoli sprouts. The AUC was 0.952 indicating our model returns accurate results and a majority of positive results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79425" y="655631"/>
            <a:ext cx="448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79425" y="4093841"/>
            <a:ext cx="448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5203" y="475280"/>
            <a:ext cx="4890694" cy="3263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6087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86</Words>
  <Application>Microsoft Office PowerPoint</Application>
  <PresentationFormat>Letter Paper (8.5x11 in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ranis, John Anthony</dc:creator>
  <cp:lastModifiedBy>Wong, Carmen</cp:lastModifiedBy>
  <cp:revision>15</cp:revision>
  <dcterms:created xsi:type="dcterms:W3CDTF">2024-05-23T23:22:09Z</dcterms:created>
  <dcterms:modified xsi:type="dcterms:W3CDTF">2024-06-25T15:33:29Z</dcterms:modified>
</cp:coreProperties>
</file>